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svg" ContentType="image/svg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5"/>
  </p:notesMasterIdLst>
  <p:sldIdLst>
    <p:sldId id="262" r:id="rId2"/>
    <p:sldId id="269" r:id="rId3"/>
    <p:sldId id="268" r:id="rId4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5940675A-B579-460E-94D1-54222C63F5DA}" styleName="スタイルなし、表のグリッド線あり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995" autoAdjust="0"/>
    <p:restoredTop sz="94660"/>
  </p:normalViewPr>
  <p:slideViewPr>
    <p:cSldViewPr snapToGrid="0">
      <p:cViewPr varScale="1">
        <p:scale>
          <a:sx n="66" d="100"/>
          <a:sy n="66" d="100"/>
        </p:scale>
        <p:origin x="2357" y="62"/>
      </p:cViewPr>
      <p:guideLst/>
    </p:cSldViewPr>
  </p:slideViewPr>
  <p:notesTextViewPr>
    <p:cViewPr>
      <p:scale>
        <a:sx n="3" d="2"/>
        <a:sy n="3" d="2"/>
      </p:scale>
      <p:origin x="0" y="0"/>
    </p:cViewPr>
  </p:notesTextViewPr>
  <p:sorterViewPr>
    <p:cViewPr varScale="1"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235568FC-C99D-4C83-93BB-DD93C77CB0CC}" type="datetimeFigureOut">
              <a:rPr kumimoji="1" lang="ja-JP" altLang="en-US" smtClean="0"/>
              <a:t>2026/3/10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C6B8BEB-0011-4201-82D7-6B76E60F3EC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8672095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89F8DE-2CF1-4D4A-AA0F-F6CEA9C154BB}" type="datetimeFigureOut">
              <a:rPr kumimoji="1" lang="ja-JP" altLang="en-US" smtClean="0"/>
              <a:t>2026/3/1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9084A3-3C49-4CDB-ADE9-387828FB0CE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5233516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89F8DE-2CF1-4D4A-AA0F-F6CEA9C154BB}" type="datetimeFigureOut">
              <a:rPr kumimoji="1" lang="ja-JP" altLang="en-US" smtClean="0"/>
              <a:t>2026/3/1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9084A3-3C49-4CDB-ADE9-387828FB0CE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9201042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89F8DE-2CF1-4D4A-AA0F-F6CEA9C154BB}" type="datetimeFigureOut">
              <a:rPr kumimoji="1" lang="ja-JP" altLang="en-US" smtClean="0"/>
              <a:t>2026/3/1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9084A3-3C49-4CDB-ADE9-387828FB0CE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965371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89F8DE-2CF1-4D4A-AA0F-F6CEA9C154BB}" type="datetimeFigureOut">
              <a:rPr kumimoji="1" lang="ja-JP" altLang="en-US" smtClean="0"/>
              <a:t>2026/3/1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9084A3-3C49-4CDB-ADE9-387828FB0CE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492370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82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82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89F8DE-2CF1-4D4A-AA0F-F6CEA9C154BB}" type="datetimeFigureOut">
              <a:rPr kumimoji="1" lang="ja-JP" altLang="en-US" smtClean="0"/>
              <a:t>2026/3/1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9084A3-3C49-4CDB-ADE9-387828FB0CE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4887622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89F8DE-2CF1-4D4A-AA0F-F6CEA9C154BB}" type="datetimeFigureOut">
              <a:rPr kumimoji="1" lang="ja-JP" altLang="en-US" smtClean="0"/>
              <a:t>2026/3/10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9084A3-3C49-4CDB-ADE9-387828FB0CE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228543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89F8DE-2CF1-4D4A-AA0F-F6CEA9C154BB}" type="datetimeFigureOut">
              <a:rPr kumimoji="1" lang="ja-JP" altLang="en-US" smtClean="0"/>
              <a:t>2026/3/10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9084A3-3C49-4CDB-ADE9-387828FB0CE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7926915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89F8DE-2CF1-4D4A-AA0F-F6CEA9C154BB}" type="datetimeFigureOut">
              <a:rPr kumimoji="1" lang="ja-JP" altLang="en-US" smtClean="0"/>
              <a:t>2026/3/10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9084A3-3C49-4CDB-ADE9-387828FB0CE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306821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89F8DE-2CF1-4D4A-AA0F-F6CEA9C154BB}" type="datetimeFigureOut">
              <a:rPr kumimoji="1" lang="ja-JP" altLang="en-US" smtClean="0"/>
              <a:t>2026/3/10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9084A3-3C49-4CDB-ADE9-387828FB0CE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5798774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89F8DE-2CF1-4D4A-AA0F-F6CEA9C154BB}" type="datetimeFigureOut">
              <a:rPr kumimoji="1" lang="ja-JP" altLang="en-US" smtClean="0"/>
              <a:t>2026/3/10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9084A3-3C49-4CDB-ADE9-387828FB0CE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1789870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89F8DE-2CF1-4D4A-AA0F-F6CEA9C154BB}" type="datetimeFigureOut">
              <a:rPr kumimoji="1" lang="ja-JP" altLang="en-US" smtClean="0"/>
              <a:t>2026/3/10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9084A3-3C49-4CDB-ADE9-387828FB0CE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6983284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8189F8DE-2CF1-4D4A-AA0F-F6CEA9C154BB}" type="datetimeFigureOut">
              <a:rPr kumimoji="1" lang="ja-JP" altLang="en-US" smtClean="0"/>
              <a:t>2026/3/1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5B9084A3-3C49-4CDB-ADE9-387828FB0CE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1729967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sv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svg"/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04A1336D-EE51-C6A6-AC00-D787F0C2B9FB}"/>
              </a:ext>
            </a:extLst>
          </p:cNvPr>
          <p:cNvSpPr txBox="1"/>
          <p:nvPr/>
        </p:nvSpPr>
        <p:spPr>
          <a:xfrm>
            <a:off x="119418" y="224766"/>
            <a:ext cx="3432412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dirty="0"/>
              <a:t>S1</a:t>
            </a:r>
            <a:r>
              <a:rPr lang="ja-JP" altLang="en-US" dirty="0"/>
              <a:t> </a:t>
            </a:r>
          </a:p>
        </p:txBody>
      </p:sp>
      <p:graphicFrame>
        <p:nvGraphicFramePr>
          <p:cNvPr id="8" name="表 7">
            <a:extLst>
              <a:ext uri="{FF2B5EF4-FFF2-40B4-BE49-F238E27FC236}">
                <a16:creationId xmlns:a16="http://schemas.microsoft.com/office/drawing/2014/main" id="{911F57DC-E919-7B6E-1CE2-B797B34D8556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583307310"/>
              </p:ext>
            </p:extLst>
          </p:nvPr>
        </p:nvGraphicFramePr>
        <p:xfrm>
          <a:off x="1231900" y="1780540"/>
          <a:ext cx="4394200" cy="6172200"/>
        </p:xfrm>
        <a:graphic>
          <a:graphicData uri="http://schemas.openxmlformats.org/drawingml/2006/table">
            <a:tbl>
              <a:tblPr/>
              <a:tblGrid>
                <a:gridCol w="1714500">
                  <a:extLst>
                    <a:ext uri="{9D8B030D-6E8A-4147-A177-3AD203B41FA5}">
                      <a16:colId xmlns:a16="http://schemas.microsoft.com/office/drawing/2014/main" val="1141815410"/>
                    </a:ext>
                  </a:extLst>
                </a:gridCol>
                <a:gridCol w="2679700">
                  <a:extLst>
                    <a:ext uri="{9D8B030D-6E8A-4147-A177-3AD203B41FA5}">
                      <a16:colId xmlns:a16="http://schemas.microsoft.com/office/drawing/2014/main" val="2191813308"/>
                    </a:ext>
                  </a:extLst>
                </a:gridCol>
              </a:tblGrid>
              <a:tr h="228600"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     Preferred Term Code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11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     Preferred Term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319168566"/>
                  </a:ext>
                </a:extLst>
              </a:tr>
              <a:tr h="228600"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ja-JP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10033625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Pancreatic haemorrhage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098485794"/>
                  </a:ext>
                </a:extLst>
              </a:tr>
              <a:tr h="228600"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ja-JP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10033635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Pancreatic pseudocyst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125307663"/>
                  </a:ext>
                </a:extLst>
              </a:tr>
              <a:tr h="228600"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ja-JP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10033636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Pancreatic pseudocyst drainage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577029462"/>
                  </a:ext>
                </a:extLst>
              </a:tr>
              <a:tr h="228600"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10033645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Pancreatitis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907040965"/>
                  </a:ext>
                </a:extLst>
              </a:tr>
              <a:tr h="228600"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ja-JP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10033647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Pancreatitis acute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488232023"/>
                  </a:ext>
                </a:extLst>
              </a:tr>
              <a:tr h="228600"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10033650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Pancreatitis </a:t>
                      </a:r>
                      <a:r>
                        <a:rPr lang="en-US" sz="11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haemorrhagic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846698031"/>
                  </a:ext>
                </a:extLst>
              </a:tr>
              <a:tr h="228600"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10033654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Pancreatitis </a:t>
                      </a:r>
                      <a:r>
                        <a:rPr lang="en-US" sz="11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necrotising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358550368"/>
                  </a:ext>
                </a:extLst>
              </a:tr>
              <a:tr h="228600"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10033657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Pancreatitis relapsing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751254742"/>
                  </a:ext>
                </a:extLst>
              </a:tr>
              <a:tr h="228600"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10048984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Pancreatic abscess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050355581"/>
                  </a:ext>
                </a:extLst>
              </a:tr>
              <a:tr h="228600"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10052400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11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Oedematous</a:t>
                      </a:r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 pancreatitis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610368168"/>
                  </a:ext>
                </a:extLst>
              </a:tr>
              <a:tr h="228600"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10055024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Pancreatic enlargement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69848139"/>
                  </a:ext>
                </a:extLst>
              </a:tr>
              <a:tr h="228600"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10056277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Pancreatorenal syndrome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404406313"/>
                  </a:ext>
                </a:extLst>
              </a:tr>
              <a:tr h="228600"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10056975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Pancreatic phlegmon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256093981"/>
                  </a:ext>
                </a:extLst>
              </a:tr>
              <a:tr h="228600"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10061900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Pancreatic enzymes increased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335758527"/>
                  </a:ext>
                </a:extLst>
              </a:tr>
              <a:tr h="228600"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10066127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11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Ischaemic</a:t>
                      </a:r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 pancreatitis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28165279"/>
                  </a:ext>
                </a:extLst>
              </a:tr>
              <a:tr h="228600"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10071369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Pancreatic cyst rupture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141909500"/>
                  </a:ext>
                </a:extLst>
              </a:tr>
              <a:tr h="228600"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10074857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Pancreatic fibrosis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051129277"/>
                  </a:ext>
                </a:extLst>
              </a:tr>
              <a:tr h="228600"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10076058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11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Haemorrhagic</a:t>
                      </a:r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 necrotic pancreatitis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308145217"/>
                  </a:ext>
                </a:extLst>
              </a:tr>
              <a:tr h="228600"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10081762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Pancreatic pseudoaneurysm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18146475"/>
                  </a:ext>
                </a:extLst>
              </a:tr>
              <a:tr h="228600"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10082531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Pancreatic cyst drainage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760878762"/>
                  </a:ext>
                </a:extLst>
              </a:tr>
              <a:tr h="228600"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10083072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Immune-mediated pancreatitis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017810505"/>
                  </a:ext>
                </a:extLst>
              </a:tr>
              <a:tr h="228600"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10083811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Pancreatic pseudocyst rupture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651699629"/>
                  </a:ext>
                </a:extLst>
              </a:tr>
              <a:tr h="228600"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10083813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Pancreatic pseudocyst </a:t>
                      </a:r>
                      <a:r>
                        <a:rPr lang="en-US" sz="11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haemorrhage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613694990"/>
                  </a:ext>
                </a:extLst>
              </a:tr>
              <a:tr h="228600"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10084554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Subacute pancreatitis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055679401"/>
                  </a:ext>
                </a:extLst>
              </a:tr>
              <a:tr h="228600"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10085347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Walled-off pancreatic necrosis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56414561"/>
                  </a:ext>
                </a:extLst>
              </a:tr>
              <a:tr h="228600"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10088882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Idiopathic pancreatitis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653274883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333834311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F892D62F-A0ED-BB24-D349-7F8DC24643A8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グラフィックス 6">
            <a:extLst>
              <a:ext uri="{FF2B5EF4-FFF2-40B4-BE49-F238E27FC236}">
                <a16:creationId xmlns:a16="http://schemas.microsoft.com/office/drawing/2014/main" id="{99C6CE50-7F15-AFD1-653D-5577038FD45B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96DAC541-7B7A-43D3-8B79-37D633B846F1}">
                <asvg:svgBlip xmlns:asvg="http://schemas.microsoft.com/office/drawing/2016/SVG/main" r:embed="rId3"/>
              </a:ext>
            </a:extLst>
          </a:blip>
          <a:stretch>
            <a:fillRect/>
          </a:stretch>
        </p:blipFill>
        <p:spPr>
          <a:xfrm>
            <a:off x="5865618" y="3447293"/>
            <a:ext cx="474767" cy="2071715"/>
          </a:xfrm>
          <a:prstGeom prst="rect">
            <a:avLst/>
          </a:prstGeom>
        </p:spPr>
      </p:pic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8FC0321E-D8AD-FCE0-FEF5-5F630E0BEB47}"/>
              </a:ext>
            </a:extLst>
          </p:cNvPr>
          <p:cNvSpPr txBox="1"/>
          <p:nvPr/>
        </p:nvSpPr>
        <p:spPr>
          <a:xfrm>
            <a:off x="119418" y="224766"/>
            <a:ext cx="3432412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dirty="0"/>
              <a:t>S2</a:t>
            </a:r>
            <a:endParaRPr lang="ja-JP" altLang="en-US" dirty="0"/>
          </a:p>
        </p:txBody>
      </p:sp>
      <p:graphicFrame>
        <p:nvGraphicFramePr>
          <p:cNvPr id="3" name="表 2">
            <a:extLst>
              <a:ext uri="{FF2B5EF4-FFF2-40B4-BE49-F238E27FC236}">
                <a16:creationId xmlns:a16="http://schemas.microsoft.com/office/drawing/2014/main" id="{44B8A1F9-9C2F-6EA3-46CA-776E8A4A4EA9}"/>
              </a:ext>
            </a:extLst>
          </p:cNvPr>
          <p:cNvGraphicFramePr>
            <a:graphicFrameLocks noGrp="1"/>
          </p:cNvGraphicFramePr>
          <p:nvPr/>
        </p:nvGraphicFramePr>
        <p:xfrm>
          <a:off x="829743" y="2789210"/>
          <a:ext cx="5536629" cy="2733758"/>
        </p:xfrm>
        <a:graphic>
          <a:graphicData uri="http://schemas.openxmlformats.org/drawingml/2006/table">
            <a:tbl>
              <a:tblPr/>
              <a:tblGrid>
                <a:gridCol w="720000">
                  <a:extLst>
                    <a:ext uri="{9D8B030D-6E8A-4147-A177-3AD203B41FA5}">
                      <a16:colId xmlns:a16="http://schemas.microsoft.com/office/drawing/2014/main" val="3577965404"/>
                    </a:ext>
                  </a:extLst>
                </a:gridCol>
                <a:gridCol w="751811">
                  <a:extLst>
                    <a:ext uri="{9D8B030D-6E8A-4147-A177-3AD203B41FA5}">
                      <a16:colId xmlns:a16="http://schemas.microsoft.com/office/drawing/2014/main" val="1651412243"/>
                    </a:ext>
                  </a:extLst>
                </a:gridCol>
                <a:gridCol w="222758">
                  <a:extLst>
                    <a:ext uri="{9D8B030D-6E8A-4147-A177-3AD203B41FA5}">
                      <a16:colId xmlns:a16="http://schemas.microsoft.com/office/drawing/2014/main" val="2390980160"/>
                    </a:ext>
                  </a:extLst>
                </a:gridCol>
                <a:gridCol w="382867">
                  <a:extLst>
                    <a:ext uri="{9D8B030D-6E8A-4147-A177-3AD203B41FA5}">
                      <a16:colId xmlns:a16="http://schemas.microsoft.com/office/drawing/2014/main" val="306730240"/>
                    </a:ext>
                  </a:extLst>
                </a:gridCol>
                <a:gridCol w="375906">
                  <a:extLst>
                    <a:ext uri="{9D8B030D-6E8A-4147-A177-3AD203B41FA5}">
                      <a16:colId xmlns:a16="http://schemas.microsoft.com/office/drawing/2014/main" val="312686484"/>
                    </a:ext>
                  </a:extLst>
                </a:gridCol>
                <a:gridCol w="389827">
                  <a:extLst>
                    <a:ext uri="{9D8B030D-6E8A-4147-A177-3AD203B41FA5}">
                      <a16:colId xmlns:a16="http://schemas.microsoft.com/office/drawing/2014/main" val="2656790056"/>
                    </a:ext>
                  </a:extLst>
                </a:gridCol>
                <a:gridCol w="72000">
                  <a:extLst>
                    <a:ext uri="{9D8B030D-6E8A-4147-A177-3AD203B41FA5}">
                      <a16:colId xmlns:a16="http://schemas.microsoft.com/office/drawing/2014/main" val="1722650571"/>
                    </a:ext>
                  </a:extLst>
                </a:gridCol>
                <a:gridCol w="355022">
                  <a:extLst>
                    <a:ext uri="{9D8B030D-6E8A-4147-A177-3AD203B41FA5}">
                      <a16:colId xmlns:a16="http://schemas.microsoft.com/office/drawing/2014/main" val="1721131098"/>
                    </a:ext>
                  </a:extLst>
                </a:gridCol>
                <a:gridCol w="288000">
                  <a:extLst>
                    <a:ext uri="{9D8B030D-6E8A-4147-A177-3AD203B41FA5}">
                      <a16:colId xmlns:a16="http://schemas.microsoft.com/office/drawing/2014/main" val="1253360296"/>
                    </a:ext>
                  </a:extLst>
                </a:gridCol>
                <a:gridCol w="288000">
                  <a:extLst>
                    <a:ext uri="{9D8B030D-6E8A-4147-A177-3AD203B41FA5}">
                      <a16:colId xmlns:a16="http://schemas.microsoft.com/office/drawing/2014/main" val="2572030751"/>
                    </a:ext>
                  </a:extLst>
                </a:gridCol>
                <a:gridCol w="288000">
                  <a:extLst>
                    <a:ext uri="{9D8B030D-6E8A-4147-A177-3AD203B41FA5}">
                      <a16:colId xmlns:a16="http://schemas.microsoft.com/office/drawing/2014/main" val="4111899986"/>
                    </a:ext>
                  </a:extLst>
                </a:gridCol>
                <a:gridCol w="288000">
                  <a:extLst>
                    <a:ext uri="{9D8B030D-6E8A-4147-A177-3AD203B41FA5}">
                      <a16:colId xmlns:a16="http://schemas.microsoft.com/office/drawing/2014/main" val="1775648594"/>
                    </a:ext>
                  </a:extLst>
                </a:gridCol>
                <a:gridCol w="288000">
                  <a:extLst>
                    <a:ext uri="{9D8B030D-6E8A-4147-A177-3AD203B41FA5}">
                      <a16:colId xmlns:a16="http://schemas.microsoft.com/office/drawing/2014/main" val="2669624908"/>
                    </a:ext>
                  </a:extLst>
                </a:gridCol>
                <a:gridCol w="288000">
                  <a:extLst>
                    <a:ext uri="{9D8B030D-6E8A-4147-A177-3AD203B41FA5}">
                      <a16:colId xmlns:a16="http://schemas.microsoft.com/office/drawing/2014/main" val="882312640"/>
                    </a:ext>
                  </a:extLst>
                </a:gridCol>
                <a:gridCol w="538438">
                  <a:extLst>
                    <a:ext uri="{9D8B030D-6E8A-4147-A177-3AD203B41FA5}">
                      <a16:colId xmlns:a16="http://schemas.microsoft.com/office/drawing/2014/main" val="3339883105"/>
                    </a:ext>
                  </a:extLst>
                </a:gridCol>
              </a:tblGrid>
              <a:tr h="224502"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endParaRPr 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5321" marR="5321" marT="532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endParaRPr 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5321" marR="5321" marT="532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gridSpan="4"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All Periods</a:t>
                      </a:r>
                    </a:p>
                  </a:txBody>
                  <a:tcPr marL="5321" marR="5321" marT="532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endParaRPr/>
                    </a:p>
                  </a:txBody>
                  <a:tcPr marL="5321" marR="5321" marT="532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fontAlgn="b">
                        <a:buNone/>
                      </a:pPr>
                      <a:endParaRPr 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5321" marR="5321" marT="532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fontAlgn="b">
                        <a:buNone/>
                      </a:pPr>
                      <a:endParaRPr 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Symbol" panose="05050102010706020507" pitchFamily="18" charset="2"/>
                        <a:ea typeface="游ゴシック" panose="020B0400000000000000" pitchFamily="50" charset="-128"/>
                      </a:endParaRPr>
                    </a:p>
                  </a:txBody>
                  <a:tcPr marL="5321" marR="5321" marT="532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5321" marR="5321" marT="532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gridSpan="8"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altLang="ja-JP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Symbol" panose="05050102010706020507" pitchFamily="18" charset="2"/>
                          <a:ea typeface="+mn-ea"/>
                        </a:rPr>
                        <a:t>W</a:t>
                      </a:r>
                      <a:r>
                        <a:rPr lang="en-US" altLang="ja-JP" sz="600" b="0" i="0" u="none" strike="noStrike" baseline="-25000" dirty="0">
                          <a:solidFill>
                            <a:srgbClr val="000000"/>
                          </a:solidFill>
                          <a:effectLst/>
                          <a:latin typeface="Symbol" panose="05050102010706020507" pitchFamily="18" charset="2"/>
                          <a:ea typeface="+mn-ea"/>
                        </a:rPr>
                        <a:t>025 </a:t>
                      </a:r>
                      <a:r>
                        <a:rPr lang="en-US" altLang="ja-JP" sz="600" b="0" i="0" u="none" strike="noStrike" baseline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+mn-ea"/>
                        </a:rPr>
                        <a:t>in each Period</a:t>
                      </a:r>
                      <a:endParaRPr lang="en-US" sz="600" b="0" i="0" u="none" strike="noStrike" baseline="0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5321" marR="5321" marT="532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endParaRPr dirty="0"/>
                    </a:p>
                  </a:txBody>
                  <a:tcPr marL="5321" marR="5321" marT="532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fontAlgn="b">
                        <a:buNone/>
                      </a:pP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Symbol" panose="05050102010706020507" pitchFamily="18" charset="2"/>
                        <a:ea typeface="游ゴシック" panose="020B0400000000000000" pitchFamily="50" charset="-128"/>
                      </a:endParaRPr>
                    </a:p>
                  </a:txBody>
                  <a:tcPr marL="5321" marR="5321" marT="532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fontAlgn="b">
                        <a:buNone/>
                      </a:pP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Symbol" panose="05050102010706020507" pitchFamily="18" charset="2"/>
                        <a:ea typeface="游ゴシック" panose="020B0400000000000000" pitchFamily="50" charset="-128"/>
                      </a:endParaRPr>
                    </a:p>
                  </a:txBody>
                  <a:tcPr marL="5321" marR="5321" marT="532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fontAlgn="b">
                        <a:buNone/>
                      </a:pP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Symbol" panose="05050102010706020507" pitchFamily="18" charset="2"/>
                        <a:ea typeface="游ゴシック" panose="020B0400000000000000" pitchFamily="50" charset="-128"/>
                      </a:endParaRPr>
                    </a:p>
                  </a:txBody>
                  <a:tcPr marL="5321" marR="5321" marT="532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fontAlgn="b">
                        <a:buNone/>
                      </a:pP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Symbol" panose="05050102010706020507" pitchFamily="18" charset="2"/>
                        <a:ea typeface="游ゴシック" panose="020B0400000000000000" pitchFamily="50" charset="-128"/>
                      </a:endParaRPr>
                    </a:p>
                  </a:txBody>
                  <a:tcPr marL="5321" marR="5321" marT="532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fontAlgn="b">
                        <a:buNone/>
                      </a:pP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Symbol" panose="05050102010706020507" pitchFamily="18" charset="2"/>
                        <a:ea typeface="游ゴシック" panose="020B0400000000000000" pitchFamily="50" charset="-128"/>
                      </a:endParaRPr>
                    </a:p>
                  </a:txBody>
                  <a:tcPr marL="5321" marR="5321" marT="532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fontAlgn="b">
                        <a:buNone/>
                      </a:pP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Symbol" panose="05050102010706020507" pitchFamily="18" charset="2"/>
                        <a:ea typeface="游ゴシック" panose="020B0400000000000000" pitchFamily="50" charset="-128"/>
                      </a:endParaRPr>
                    </a:p>
                  </a:txBody>
                  <a:tcPr marL="5321" marR="5321" marT="532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742420628"/>
                  </a:ext>
                </a:extLst>
              </a:tr>
              <a:tr h="432000"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Drug A</a:t>
                      </a:r>
                    </a:p>
                  </a:txBody>
                  <a:tcPr marL="5321" marR="5321" marT="532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Drug B</a:t>
                      </a:r>
                    </a:p>
                  </a:txBody>
                  <a:tcPr marL="5321" marR="5321" marT="532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n</a:t>
                      </a:r>
                      <a:r>
                        <a:rPr lang="en-US" sz="700" b="0" i="0" u="none" strike="noStrike" baseline="-250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111</a:t>
                      </a:r>
                      <a:endParaRPr 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5321" marR="5321" marT="532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n</a:t>
                      </a:r>
                      <a:r>
                        <a:rPr lang="en-US" sz="700" b="0" i="0" u="none" strike="noStrike" baseline="-250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11+</a:t>
                      </a:r>
                      <a:endParaRPr 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5321" marR="5321" marT="532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E</a:t>
                      </a:r>
                      <a:r>
                        <a:rPr lang="en-US" sz="700" b="0" i="0" u="none" strike="noStrike" baseline="-250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111</a:t>
                      </a:r>
                      <a:endParaRPr 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5321" marR="5321" marT="532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Symbol" panose="05050102010706020507" pitchFamily="18" charset="2"/>
                          <a:ea typeface="游ゴシック" panose="020B0400000000000000" pitchFamily="50" charset="-128"/>
                        </a:rPr>
                        <a:t>W</a:t>
                      </a:r>
                      <a:r>
                        <a:rPr lang="en-US" sz="700" b="0" i="0" u="none" strike="noStrike" baseline="-25000" dirty="0">
                          <a:solidFill>
                            <a:srgbClr val="000000"/>
                          </a:solidFill>
                          <a:effectLst/>
                          <a:latin typeface="Symbol" panose="05050102010706020507" pitchFamily="18" charset="2"/>
                          <a:ea typeface="游ゴシック" panose="020B0400000000000000" pitchFamily="50" charset="-128"/>
                        </a:rPr>
                        <a:t>025</a:t>
                      </a:r>
                      <a:endParaRPr 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Symbol" panose="05050102010706020507" pitchFamily="18" charset="2"/>
                        <a:ea typeface="游ゴシック" panose="020B0400000000000000" pitchFamily="50" charset="-128"/>
                      </a:endParaRPr>
                    </a:p>
                  </a:txBody>
                  <a:tcPr marL="5321" marR="5321" marT="532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5321" marR="5321" marT="532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Numb of Positive signal</a:t>
                      </a:r>
                    </a:p>
                  </a:txBody>
                  <a:tcPr marL="5321" marR="5321" marT="532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Period1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Symbol" panose="05050102010706020507" pitchFamily="18" charset="2"/>
                        <a:ea typeface="游ゴシック" panose="020B0400000000000000" pitchFamily="50" charset="-128"/>
                      </a:endParaRPr>
                    </a:p>
                  </a:txBody>
                  <a:tcPr marL="5321" marR="5321" marT="532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Period2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Symbol" panose="05050102010706020507" pitchFamily="18" charset="2"/>
                        <a:ea typeface="游ゴシック" panose="020B0400000000000000" pitchFamily="50" charset="-128"/>
                      </a:endParaRPr>
                    </a:p>
                  </a:txBody>
                  <a:tcPr marL="5321" marR="5321" marT="532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Period3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Symbol" panose="05050102010706020507" pitchFamily="18" charset="2"/>
                        <a:ea typeface="游ゴシック" panose="020B0400000000000000" pitchFamily="50" charset="-128"/>
                      </a:endParaRPr>
                    </a:p>
                  </a:txBody>
                  <a:tcPr marL="5321" marR="5321" marT="532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Period4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Symbol" panose="05050102010706020507" pitchFamily="18" charset="2"/>
                        <a:ea typeface="游ゴシック" panose="020B0400000000000000" pitchFamily="50" charset="-128"/>
                      </a:endParaRPr>
                    </a:p>
                  </a:txBody>
                  <a:tcPr marL="5321" marR="5321" marT="532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Period5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Symbol" panose="05050102010706020507" pitchFamily="18" charset="2"/>
                        <a:ea typeface="游ゴシック" panose="020B0400000000000000" pitchFamily="50" charset="-128"/>
                      </a:endParaRPr>
                    </a:p>
                  </a:txBody>
                  <a:tcPr marL="5321" marR="5321" marT="532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Period6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Symbol" panose="05050102010706020507" pitchFamily="18" charset="2"/>
                        <a:ea typeface="游ゴシック" panose="020B0400000000000000" pitchFamily="50" charset="-128"/>
                      </a:endParaRPr>
                    </a:p>
                  </a:txBody>
                  <a:tcPr marL="5321" marR="5321" marT="532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+mn-ea"/>
                        </a:rPr>
                        <a:t>Transition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Symbol" panose="05050102010706020507" pitchFamily="18" charset="2"/>
                        <a:ea typeface="游ゴシック" panose="020B0400000000000000" pitchFamily="50" charset="-128"/>
                      </a:endParaRPr>
                    </a:p>
                  </a:txBody>
                  <a:tcPr marL="5321" marR="5321" marT="532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850606202"/>
                  </a:ext>
                </a:extLst>
              </a:tr>
              <a:tr h="259657"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Atorvastatin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Dulaglutide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en-US" altLang="ja-JP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133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3,226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82.97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0.43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endParaRPr lang="en-US" altLang="ja-JP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5321" marR="5321" marT="532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altLang="ja-JP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4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ja-JP" alt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0.01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0.27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0.8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0.35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-0.94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endParaRPr lang="en-US" altLang="ja-JP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5321" marR="5321" marT="532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97937780"/>
                  </a:ext>
                </a:extLst>
              </a:tr>
              <a:tr h="259657"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Exenatide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Simvastatin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en-US" altLang="ja-JP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331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en-US" altLang="ja-JP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3,342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en-US" altLang="ja-JP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110.85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en-US" altLang="ja-JP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1.42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endParaRPr lang="en-US" altLang="ja-JP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5321" marR="5321" marT="532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altLang="ja-JP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2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1.63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0.59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en-US" altLang="ja-JP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-1.41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-2.26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endParaRPr lang="en-US" altLang="ja-JP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5321" marR="5321" marT="532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450925069"/>
                  </a:ext>
                </a:extLst>
              </a:tr>
              <a:tr h="259657"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Atorvastatin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Exenatide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300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4,469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en-US" altLang="ja-JP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149.2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en-US" altLang="ja-JP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0.84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endParaRPr lang="en-US" altLang="ja-JP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5321" marR="5321" marT="532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altLang="ja-JP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2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en-US" altLang="ja-JP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1.22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0.44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-0.32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-1.23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-2.16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-0.92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endParaRPr lang="en-US" altLang="ja-JP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5321" marR="5321" marT="532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651535813"/>
                  </a:ext>
                </a:extLst>
              </a:tr>
              <a:tr h="259657"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Exenatide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Rosuvastatin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137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1,935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67.9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0.77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endParaRPr lang="en-US" altLang="ja-JP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5321" marR="5321" marT="532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altLang="ja-JP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2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en-US" altLang="ja-JP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1.37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en-US" altLang="ja-JP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0.03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en-US" altLang="ja-JP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-1.31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en-US" altLang="ja-JP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-3.98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-2.84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endParaRPr lang="en-US" altLang="ja-JP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5321" marR="5321" marT="532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950001002"/>
                  </a:ext>
                </a:extLst>
              </a:tr>
              <a:tr h="259657"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Dulaglutide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Simvastatin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41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868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24.03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0.32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endParaRPr lang="en-US" altLang="ja-JP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5321" marR="5321" marT="532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altLang="ja-JP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2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en-US" altLang="ja-JP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0.69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en-US" altLang="ja-JP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0.36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en-US" altLang="ja-JP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-1.88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en-US" altLang="ja-JP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-1.5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-0.85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endParaRPr lang="en-US" altLang="ja-JP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5321" marR="5321" marT="532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746060637"/>
                  </a:ext>
                </a:extLst>
              </a:tr>
              <a:tr h="259657"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Liraglutide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Simvastatin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213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2,000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141.18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0.4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endParaRPr lang="en-US" altLang="ja-JP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5321" marR="5321" marT="532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altLang="ja-JP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1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1.17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-0.2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en-US" altLang="ja-JP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-0.72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en-US" altLang="ja-JP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-3.54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en-US" altLang="ja-JP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-0.43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-1.48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endParaRPr lang="ja-JP" alt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5321" marR="5321" marT="532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288721872"/>
                  </a:ext>
                </a:extLst>
              </a:tr>
              <a:tr h="259657"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Exenatide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Pravastatin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69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956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33.34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0.7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endParaRPr lang="en-US" altLang="ja-JP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5321" marR="5321" marT="532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altLang="ja-JP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1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1.37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-0.57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-3.59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ja-JP" alt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ja-JP" alt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ja-JP" alt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endParaRPr lang="ja-JP" alt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5321" marR="5321" marT="532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776284619"/>
                  </a:ext>
                </a:extLst>
              </a:tr>
              <a:tr h="259657"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Exenatide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Lovastatin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en-US" altLang="ja-JP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39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en-US" altLang="ja-JP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471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en-US" altLang="ja-JP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16.2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en-US" altLang="ja-JP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0.79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endParaRPr lang="en-US" altLang="ja-JP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5321" marR="5321" marT="532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altLang="ja-JP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1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en-US" altLang="ja-JP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1.18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en-US" altLang="ja-JP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-1.98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en-US" altLang="ja-JP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-2.55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ja-JP" alt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ja-JP" alt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ja-JP" alt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endParaRPr lang="ja-JP" alt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5321" marR="5321" marT="532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754541461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290165125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15C76184-0556-E544-9346-14F5D90824AE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グラフィックス 5">
            <a:extLst>
              <a:ext uri="{FF2B5EF4-FFF2-40B4-BE49-F238E27FC236}">
                <a16:creationId xmlns:a16="http://schemas.microsoft.com/office/drawing/2014/main" id="{3F5E4807-5D35-A3FA-D28B-29C3F914FAC4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96DAC541-7B7A-43D3-8B79-37D633B846F1}">
                <asvg:svgBlip xmlns:asvg="http://schemas.microsoft.com/office/drawing/2016/SVG/main" r:embed="rId3"/>
              </a:ext>
            </a:extLst>
          </a:blip>
          <a:stretch>
            <a:fillRect/>
          </a:stretch>
        </p:blipFill>
        <p:spPr>
          <a:xfrm>
            <a:off x="5811718" y="2527003"/>
            <a:ext cx="480935" cy="4459565"/>
          </a:xfrm>
          <a:prstGeom prst="rect">
            <a:avLst/>
          </a:prstGeom>
        </p:spPr>
      </p:pic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94CEC8D5-7591-69FB-7E0B-AAC037E93235}"/>
              </a:ext>
            </a:extLst>
          </p:cNvPr>
          <p:cNvSpPr txBox="1"/>
          <p:nvPr/>
        </p:nvSpPr>
        <p:spPr>
          <a:xfrm>
            <a:off x="119418" y="224766"/>
            <a:ext cx="3432412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dirty="0"/>
              <a:t>S3</a:t>
            </a:r>
            <a:endParaRPr lang="ja-JP" altLang="en-US" dirty="0"/>
          </a:p>
        </p:txBody>
      </p:sp>
      <p:graphicFrame>
        <p:nvGraphicFramePr>
          <p:cNvPr id="3" name="表 2">
            <a:extLst>
              <a:ext uri="{FF2B5EF4-FFF2-40B4-BE49-F238E27FC236}">
                <a16:creationId xmlns:a16="http://schemas.microsoft.com/office/drawing/2014/main" id="{8CB93EAE-5F16-CF46-3016-A090B1AC36A7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314969447"/>
              </p:ext>
            </p:extLst>
          </p:nvPr>
        </p:nvGraphicFramePr>
        <p:xfrm>
          <a:off x="783515" y="1902105"/>
          <a:ext cx="5536629" cy="5070671"/>
        </p:xfrm>
        <a:graphic>
          <a:graphicData uri="http://schemas.openxmlformats.org/drawingml/2006/table">
            <a:tbl>
              <a:tblPr/>
              <a:tblGrid>
                <a:gridCol w="720000">
                  <a:extLst>
                    <a:ext uri="{9D8B030D-6E8A-4147-A177-3AD203B41FA5}">
                      <a16:colId xmlns:a16="http://schemas.microsoft.com/office/drawing/2014/main" val="3577965404"/>
                    </a:ext>
                  </a:extLst>
                </a:gridCol>
                <a:gridCol w="751811">
                  <a:extLst>
                    <a:ext uri="{9D8B030D-6E8A-4147-A177-3AD203B41FA5}">
                      <a16:colId xmlns:a16="http://schemas.microsoft.com/office/drawing/2014/main" val="1651412243"/>
                    </a:ext>
                  </a:extLst>
                </a:gridCol>
                <a:gridCol w="222758">
                  <a:extLst>
                    <a:ext uri="{9D8B030D-6E8A-4147-A177-3AD203B41FA5}">
                      <a16:colId xmlns:a16="http://schemas.microsoft.com/office/drawing/2014/main" val="2390980160"/>
                    </a:ext>
                  </a:extLst>
                </a:gridCol>
                <a:gridCol w="382867">
                  <a:extLst>
                    <a:ext uri="{9D8B030D-6E8A-4147-A177-3AD203B41FA5}">
                      <a16:colId xmlns:a16="http://schemas.microsoft.com/office/drawing/2014/main" val="306730240"/>
                    </a:ext>
                  </a:extLst>
                </a:gridCol>
                <a:gridCol w="375906">
                  <a:extLst>
                    <a:ext uri="{9D8B030D-6E8A-4147-A177-3AD203B41FA5}">
                      <a16:colId xmlns:a16="http://schemas.microsoft.com/office/drawing/2014/main" val="312686484"/>
                    </a:ext>
                  </a:extLst>
                </a:gridCol>
                <a:gridCol w="389827">
                  <a:extLst>
                    <a:ext uri="{9D8B030D-6E8A-4147-A177-3AD203B41FA5}">
                      <a16:colId xmlns:a16="http://schemas.microsoft.com/office/drawing/2014/main" val="2656790056"/>
                    </a:ext>
                  </a:extLst>
                </a:gridCol>
                <a:gridCol w="72000">
                  <a:extLst>
                    <a:ext uri="{9D8B030D-6E8A-4147-A177-3AD203B41FA5}">
                      <a16:colId xmlns:a16="http://schemas.microsoft.com/office/drawing/2014/main" val="1722650571"/>
                    </a:ext>
                  </a:extLst>
                </a:gridCol>
                <a:gridCol w="355022">
                  <a:extLst>
                    <a:ext uri="{9D8B030D-6E8A-4147-A177-3AD203B41FA5}">
                      <a16:colId xmlns:a16="http://schemas.microsoft.com/office/drawing/2014/main" val="1721131098"/>
                    </a:ext>
                  </a:extLst>
                </a:gridCol>
                <a:gridCol w="288000">
                  <a:extLst>
                    <a:ext uri="{9D8B030D-6E8A-4147-A177-3AD203B41FA5}">
                      <a16:colId xmlns:a16="http://schemas.microsoft.com/office/drawing/2014/main" val="1253360296"/>
                    </a:ext>
                  </a:extLst>
                </a:gridCol>
                <a:gridCol w="288000">
                  <a:extLst>
                    <a:ext uri="{9D8B030D-6E8A-4147-A177-3AD203B41FA5}">
                      <a16:colId xmlns:a16="http://schemas.microsoft.com/office/drawing/2014/main" val="2572030751"/>
                    </a:ext>
                  </a:extLst>
                </a:gridCol>
                <a:gridCol w="288000">
                  <a:extLst>
                    <a:ext uri="{9D8B030D-6E8A-4147-A177-3AD203B41FA5}">
                      <a16:colId xmlns:a16="http://schemas.microsoft.com/office/drawing/2014/main" val="4111899986"/>
                    </a:ext>
                  </a:extLst>
                </a:gridCol>
                <a:gridCol w="288000">
                  <a:extLst>
                    <a:ext uri="{9D8B030D-6E8A-4147-A177-3AD203B41FA5}">
                      <a16:colId xmlns:a16="http://schemas.microsoft.com/office/drawing/2014/main" val="1775648594"/>
                    </a:ext>
                  </a:extLst>
                </a:gridCol>
                <a:gridCol w="288000">
                  <a:extLst>
                    <a:ext uri="{9D8B030D-6E8A-4147-A177-3AD203B41FA5}">
                      <a16:colId xmlns:a16="http://schemas.microsoft.com/office/drawing/2014/main" val="2669624908"/>
                    </a:ext>
                  </a:extLst>
                </a:gridCol>
                <a:gridCol w="288000">
                  <a:extLst>
                    <a:ext uri="{9D8B030D-6E8A-4147-A177-3AD203B41FA5}">
                      <a16:colId xmlns:a16="http://schemas.microsoft.com/office/drawing/2014/main" val="882312640"/>
                    </a:ext>
                  </a:extLst>
                </a:gridCol>
                <a:gridCol w="538438">
                  <a:extLst>
                    <a:ext uri="{9D8B030D-6E8A-4147-A177-3AD203B41FA5}">
                      <a16:colId xmlns:a16="http://schemas.microsoft.com/office/drawing/2014/main" val="3339883105"/>
                    </a:ext>
                  </a:extLst>
                </a:gridCol>
              </a:tblGrid>
              <a:tr h="224502"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endParaRPr 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5321" marR="5321" marT="532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endParaRPr 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5321" marR="5321" marT="532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gridSpan="4"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All Periods</a:t>
                      </a:r>
                    </a:p>
                  </a:txBody>
                  <a:tcPr marL="5321" marR="5321" marT="532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endParaRPr/>
                    </a:p>
                  </a:txBody>
                  <a:tcPr marL="5321" marR="5321" marT="532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fontAlgn="b">
                        <a:buNone/>
                      </a:pPr>
                      <a:endParaRPr 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5321" marR="5321" marT="532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fontAlgn="b">
                        <a:buNone/>
                      </a:pPr>
                      <a:endParaRPr 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Symbol" panose="05050102010706020507" pitchFamily="18" charset="2"/>
                        <a:ea typeface="游ゴシック" panose="020B0400000000000000" pitchFamily="50" charset="-128"/>
                      </a:endParaRPr>
                    </a:p>
                  </a:txBody>
                  <a:tcPr marL="5321" marR="5321" marT="532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5321" marR="5321" marT="532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gridSpan="8"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altLang="ja-JP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Symbol" panose="05050102010706020507" pitchFamily="18" charset="2"/>
                          <a:ea typeface="+mn-ea"/>
                        </a:rPr>
                        <a:t>W</a:t>
                      </a:r>
                      <a:r>
                        <a:rPr lang="en-US" altLang="ja-JP" sz="600" b="0" i="0" u="none" strike="noStrike" baseline="-25000" dirty="0">
                          <a:solidFill>
                            <a:srgbClr val="000000"/>
                          </a:solidFill>
                          <a:effectLst/>
                          <a:latin typeface="Symbol" panose="05050102010706020507" pitchFamily="18" charset="2"/>
                          <a:ea typeface="+mn-ea"/>
                        </a:rPr>
                        <a:t>025 </a:t>
                      </a:r>
                      <a:r>
                        <a:rPr lang="en-US" altLang="ja-JP" sz="600" b="0" i="0" u="none" strike="noStrike" baseline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+mn-ea"/>
                        </a:rPr>
                        <a:t>in each Period</a:t>
                      </a:r>
                      <a:endParaRPr lang="en-US" sz="600" b="0" i="0" u="none" strike="noStrike" baseline="0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5321" marR="5321" marT="532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endParaRPr dirty="0"/>
                    </a:p>
                  </a:txBody>
                  <a:tcPr marL="5321" marR="5321" marT="532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fontAlgn="b">
                        <a:buNone/>
                      </a:pP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Symbol" panose="05050102010706020507" pitchFamily="18" charset="2"/>
                        <a:ea typeface="游ゴシック" panose="020B0400000000000000" pitchFamily="50" charset="-128"/>
                      </a:endParaRPr>
                    </a:p>
                  </a:txBody>
                  <a:tcPr marL="5321" marR="5321" marT="532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fontAlgn="b">
                        <a:buNone/>
                      </a:pP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Symbol" panose="05050102010706020507" pitchFamily="18" charset="2"/>
                        <a:ea typeface="游ゴシック" panose="020B0400000000000000" pitchFamily="50" charset="-128"/>
                      </a:endParaRPr>
                    </a:p>
                  </a:txBody>
                  <a:tcPr marL="5321" marR="5321" marT="532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fontAlgn="b">
                        <a:buNone/>
                      </a:pP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Symbol" panose="05050102010706020507" pitchFamily="18" charset="2"/>
                        <a:ea typeface="游ゴシック" panose="020B0400000000000000" pitchFamily="50" charset="-128"/>
                      </a:endParaRPr>
                    </a:p>
                  </a:txBody>
                  <a:tcPr marL="5321" marR="5321" marT="532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fontAlgn="b">
                        <a:buNone/>
                      </a:pP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Symbol" panose="05050102010706020507" pitchFamily="18" charset="2"/>
                        <a:ea typeface="游ゴシック" panose="020B0400000000000000" pitchFamily="50" charset="-128"/>
                      </a:endParaRPr>
                    </a:p>
                  </a:txBody>
                  <a:tcPr marL="5321" marR="5321" marT="532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fontAlgn="b">
                        <a:buNone/>
                      </a:pP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Symbol" panose="05050102010706020507" pitchFamily="18" charset="2"/>
                        <a:ea typeface="游ゴシック" panose="020B0400000000000000" pitchFamily="50" charset="-128"/>
                      </a:endParaRPr>
                    </a:p>
                  </a:txBody>
                  <a:tcPr marL="5321" marR="5321" marT="532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fontAlgn="b">
                        <a:buNone/>
                      </a:pP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Symbol" panose="05050102010706020507" pitchFamily="18" charset="2"/>
                        <a:ea typeface="游ゴシック" panose="020B0400000000000000" pitchFamily="50" charset="-128"/>
                      </a:endParaRPr>
                    </a:p>
                  </a:txBody>
                  <a:tcPr marL="5321" marR="5321" marT="532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742420628"/>
                  </a:ext>
                </a:extLst>
              </a:tr>
              <a:tr h="432000"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Drug A</a:t>
                      </a:r>
                    </a:p>
                  </a:txBody>
                  <a:tcPr marL="5321" marR="5321" marT="532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Drug B</a:t>
                      </a:r>
                    </a:p>
                  </a:txBody>
                  <a:tcPr marL="5321" marR="5321" marT="532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n</a:t>
                      </a:r>
                      <a:r>
                        <a:rPr lang="en-US" sz="700" b="0" i="0" u="none" strike="noStrike" baseline="-250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111</a:t>
                      </a:r>
                      <a:endParaRPr 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5321" marR="5321" marT="532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n</a:t>
                      </a:r>
                      <a:r>
                        <a:rPr lang="en-US" sz="700" b="0" i="0" u="none" strike="noStrike" baseline="-250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11+</a:t>
                      </a:r>
                      <a:endParaRPr 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5321" marR="5321" marT="532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E</a:t>
                      </a:r>
                      <a:r>
                        <a:rPr lang="en-US" sz="700" b="0" i="0" u="none" strike="noStrike" baseline="-250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111</a:t>
                      </a:r>
                      <a:endParaRPr 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5321" marR="5321" marT="532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Symbol" panose="05050102010706020507" pitchFamily="18" charset="2"/>
                          <a:ea typeface="游ゴシック" panose="020B0400000000000000" pitchFamily="50" charset="-128"/>
                        </a:rPr>
                        <a:t>W</a:t>
                      </a:r>
                      <a:r>
                        <a:rPr lang="en-US" sz="700" b="0" i="0" u="none" strike="noStrike" baseline="-25000" dirty="0">
                          <a:solidFill>
                            <a:srgbClr val="000000"/>
                          </a:solidFill>
                          <a:effectLst/>
                          <a:latin typeface="Symbol" panose="05050102010706020507" pitchFamily="18" charset="2"/>
                          <a:ea typeface="游ゴシック" panose="020B0400000000000000" pitchFamily="50" charset="-128"/>
                        </a:rPr>
                        <a:t>025</a:t>
                      </a:r>
                      <a:endParaRPr 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Symbol" panose="05050102010706020507" pitchFamily="18" charset="2"/>
                        <a:ea typeface="游ゴシック" panose="020B0400000000000000" pitchFamily="50" charset="-128"/>
                      </a:endParaRPr>
                    </a:p>
                  </a:txBody>
                  <a:tcPr marL="5321" marR="5321" marT="532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5321" marR="5321" marT="532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Numb of Positive signal</a:t>
                      </a:r>
                    </a:p>
                  </a:txBody>
                  <a:tcPr marL="5321" marR="5321" marT="532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Period1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Symbol" panose="05050102010706020507" pitchFamily="18" charset="2"/>
                        <a:ea typeface="游ゴシック" panose="020B0400000000000000" pitchFamily="50" charset="-128"/>
                      </a:endParaRPr>
                    </a:p>
                  </a:txBody>
                  <a:tcPr marL="5321" marR="5321" marT="532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Period2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Symbol" panose="05050102010706020507" pitchFamily="18" charset="2"/>
                        <a:ea typeface="游ゴシック" panose="020B0400000000000000" pitchFamily="50" charset="-128"/>
                      </a:endParaRPr>
                    </a:p>
                  </a:txBody>
                  <a:tcPr marL="5321" marR="5321" marT="532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Period3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Symbol" panose="05050102010706020507" pitchFamily="18" charset="2"/>
                        <a:ea typeface="游ゴシック" panose="020B0400000000000000" pitchFamily="50" charset="-128"/>
                      </a:endParaRPr>
                    </a:p>
                  </a:txBody>
                  <a:tcPr marL="5321" marR="5321" marT="532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Period4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Symbol" panose="05050102010706020507" pitchFamily="18" charset="2"/>
                        <a:ea typeface="游ゴシック" panose="020B0400000000000000" pitchFamily="50" charset="-128"/>
                      </a:endParaRPr>
                    </a:p>
                  </a:txBody>
                  <a:tcPr marL="5321" marR="5321" marT="532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Period5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Symbol" panose="05050102010706020507" pitchFamily="18" charset="2"/>
                        <a:ea typeface="游ゴシック" panose="020B0400000000000000" pitchFamily="50" charset="-128"/>
                      </a:endParaRPr>
                    </a:p>
                  </a:txBody>
                  <a:tcPr marL="5321" marR="5321" marT="532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Period6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Symbol" panose="05050102010706020507" pitchFamily="18" charset="2"/>
                        <a:ea typeface="游ゴシック" panose="020B0400000000000000" pitchFamily="50" charset="-128"/>
                      </a:endParaRPr>
                    </a:p>
                  </a:txBody>
                  <a:tcPr marL="5321" marR="5321" marT="532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+mn-ea"/>
                        </a:rPr>
                        <a:t>Transition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Symbol" panose="05050102010706020507" pitchFamily="18" charset="2"/>
                        <a:ea typeface="游ゴシック" panose="020B0400000000000000" pitchFamily="50" charset="-128"/>
                      </a:endParaRPr>
                    </a:p>
                  </a:txBody>
                  <a:tcPr marL="5321" marR="5321" marT="532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850606202"/>
                  </a:ext>
                </a:extLst>
              </a:tr>
              <a:tr h="259657"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Liraglutide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Lisinopril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273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2,488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174.34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0.47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endParaRPr lang="en-US" altLang="ja-JP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5321" marR="5321" marT="532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3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1.67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0.06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0.03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-4.18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-2.69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-2.18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endParaRPr lang="en-US" altLang="ja-JP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5321" marR="5321" marT="532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97937780"/>
                  </a:ext>
                </a:extLst>
              </a:tr>
              <a:tr h="259657"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Enalapril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Exenatide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88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627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23.46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1.58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endParaRPr lang="en-US" altLang="ja-JP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5321" marR="5321" marT="532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3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1.32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0.99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-0.47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3.23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endParaRPr lang="en-US" altLang="ja-JP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5321" marR="5321" marT="532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450925069"/>
                  </a:ext>
                </a:extLst>
              </a:tr>
              <a:tr h="259657"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Exenatide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Lisinopril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altLang="ja-JP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381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4,661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154.66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1.15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endParaRPr lang="en-US" altLang="ja-JP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5321" marR="5321" marT="532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2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1.7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0.31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-0.58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-3.5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-3.46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endParaRPr lang="en-US" altLang="ja-JP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5321" marR="5321" marT="532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651535813"/>
                  </a:ext>
                </a:extLst>
              </a:tr>
              <a:tr h="259657"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Exenatide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Ramipril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100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altLang="ja-JP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1,024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37.68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1.11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endParaRPr lang="en-US" altLang="ja-JP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5321" marR="5321" marT="532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2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1.01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0.38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-0.39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-0.69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-2.04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endParaRPr lang="en-US" altLang="ja-JP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5321" marR="5321" marT="532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950001002"/>
                  </a:ext>
                </a:extLst>
              </a:tr>
              <a:tr h="259657"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Dulaglutide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Perindopril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26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203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altLang="ja-JP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6.4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1.39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endParaRPr lang="en-US" altLang="ja-JP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5321" marR="5321" marT="532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2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-1.91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1.8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-4.05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1.54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-0.19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endParaRPr lang="en-US" altLang="ja-JP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5321" marR="5321" marT="532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746060637"/>
                  </a:ext>
                </a:extLst>
              </a:tr>
              <a:tr h="259657"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Liraglutide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Quinapril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17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98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7.08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0.52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endParaRPr lang="en-US" altLang="ja-JP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5321" marR="5321" marT="532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2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0.66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0.16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-2.74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endParaRPr lang="ja-JP" alt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5321" marR="5321" marT="532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288721872"/>
                  </a:ext>
                </a:extLst>
              </a:tr>
              <a:tr h="259657"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Exenatide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Perindopril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16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142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5.87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altLang="ja-JP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0.67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endParaRPr lang="en-US" altLang="ja-JP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5321" marR="5321" marT="532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2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0.51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0.38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-1.29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endParaRPr lang="ja-JP" alt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5321" marR="5321" marT="532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776284619"/>
                  </a:ext>
                </a:extLst>
              </a:tr>
              <a:tr h="259657"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Dulaglutide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Enalapril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altLang="ja-JP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14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197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5.85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0.44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endParaRPr lang="en-US" altLang="ja-JP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5321" marR="5321" marT="532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altLang="ja-JP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2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-0.22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0.24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0.57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-2.84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endParaRPr lang="ja-JP" alt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5321" marR="5321" marT="532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754541461"/>
                  </a:ext>
                </a:extLst>
              </a:tr>
              <a:tr h="259657"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Benazepril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Exenatide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59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altLang="ja-JP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601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21.01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1.1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endParaRPr lang="en-US" altLang="ja-JP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5321" marR="5321" marT="532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1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altLang="ja-JP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1.34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-2.67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-2.7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endParaRPr lang="ja-JP" alt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5321" marR="5321" marT="532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238472374"/>
                  </a:ext>
                </a:extLst>
              </a:tr>
              <a:tr h="259657"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Exenatide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Quinapril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33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367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13.23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0.79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endParaRPr lang="en-US" altLang="ja-JP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5321" marR="5321" marT="532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1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altLang="ja-JP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0.75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-3.97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-0.5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-1.47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endParaRPr lang="ja-JP" alt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5321" marR="5321" marT="532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819135416"/>
                  </a:ext>
                </a:extLst>
              </a:tr>
              <a:tr h="259657"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Dulaglutide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Ramipril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27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545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altLang="ja-JP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15.54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0.23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endParaRPr lang="en-US" altLang="ja-JP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5321" marR="5321" marT="532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1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altLang="ja-JP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-0.45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altLang="ja-JP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-0.99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0.33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-0.44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-2.2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endParaRPr lang="ja-JP" alt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5321" marR="5321" marT="532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501262883"/>
                  </a:ext>
                </a:extLst>
              </a:tr>
              <a:tr h="259657"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Benazepril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Liraglutide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27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227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altLang="ja-JP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16.23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0.17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endParaRPr lang="en-US" altLang="ja-JP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5321" marR="5321" marT="532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1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1.07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-0.17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endParaRPr lang="ja-JP" alt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-2.92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endParaRPr lang="ja-JP" alt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5321" marR="5321" marT="532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135784881"/>
                  </a:ext>
                </a:extLst>
              </a:tr>
              <a:tr h="259657"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Perindopril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Saxagliptin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14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146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6.23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0.35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endParaRPr lang="en-US" altLang="ja-JP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5321" marR="5321" marT="532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1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-0.58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-0.18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-2.41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endParaRPr lang="ja-JP" alt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-0.32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0.37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endParaRPr lang="ja-JP" alt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5321" marR="5321" marT="532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381117373"/>
                  </a:ext>
                </a:extLst>
              </a:tr>
              <a:tr h="259657"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Exenatide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8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Fosinopril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13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135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5.28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0.44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endParaRPr lang="en-US" altLang="ja-JP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5321" marR="5321" marT="532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1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0.6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altLang="ja-JP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-3.01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endParaRPr lang="ja-JP" alt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endParaRPr lang="ja-JP" alt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5321" marR="5321" marT="532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352806475"/>
                  </a:ext>
                </a:extLst>
              </a:tr>
              <a:tr h="259657"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Exenatide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Trandolapril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9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66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2.83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0.57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endParaRPr lang="en-US" altLang="ja-JP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5321" marR="5321" marT="532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1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0.43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-2.16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endParaRPr lang="ja-JP" alt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endParaRPr lang="ja-JP" alt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endParaRPr lang="ja-JP" alt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endParaRPr lang="ja-JP" alt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5321" marR="5321" marT="532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594817352"/>
                  </a:ext>
                </a:extLst>
              </a:tr>
              <a:tr h="259657"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Enalaprilat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Exenatide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9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95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3.84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0.19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endParaRPr lang="en-US" altLang="ja-JP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5321" marR="5321" marT="532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1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0.25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endParaRPr lang="ja-JP" alt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endParaRPr lang="ja-JP" alt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endParaRPr lang="ja-JP" alt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5321" marR="5321" marT="532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46401428"/>
                  </a:ext>
                </a:extLst>
              </a:tr>
              <a:tr h="259657"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8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Saxagliptin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Trandolapril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altLang="ja-JP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6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altLang="ja-JP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26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altLang="ja-JP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1.17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altLang="ja-JP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0.81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endParaRPr lang="en-US" altLang="ja-JP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5321" marR="5321" marT="532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altLang="ja-JP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1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0.86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altLang="ja-JP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-2.15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endParaRPr lang="ja-JP" alt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endParaRPr lang="ja-JP" alt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endParaRPr lang="ja-JP" alt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endParaRPr lang="ja-JP" alt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endParaRPr lang="ja-JP" alt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5321" marR="5321" marT="532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775369882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271921455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 テーマ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游ゴシック Light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645</TotalTime>
  <Words>478</Words>
  <Application>Microsoft Office PowerPoint</Application>
  <PresentationFormat>A4 210 x 297 mm</PresentationFormat>
  <Paragraphs>363</Paragraphs>
  <Slides>3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5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3</vt:i4>
      </vt:variant>
    </vt:vector>
  </HeadingPairs>
  <TitlesOfParts>
    <vt:vector size="9" baseType="lpstr">
      <vt:lpstr>游ゴシック</vt:lpstr>
      <vt:lpstr>Aptos</vt:lpstr>
      <vt:lpstr>Aptos Display</vt:lpstr>
      <vt:lpstr>Arial</vt:lpstr>
      <vt:lpstr>Symbol</vt:lpstr>
      <vt:lpstr>Office テーマ</vt:lpstr>
      <vt:lpstr>PowerPoint プレゼンテーション</vt:lpstr>
      <vt:lpstr>PowerPoint プレゼンテーション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knjond 恩田 健二</dc:creator>
  <cp:lastModifiedBy>knjond 恩田 健二</cp:lastModifiedBy>
  <cp:revision>42</cp:revision>
  <dcterms:created xsi:type="dcterms:W3CDTF">2025-12-04T00:57:42Z</dcterms:created>
  <dcterms:modified xsi:type="dcterms:W3CDTF">2026-03-10T03:56:34Z</dcterms:modified>
</cp:coreProperties>
</file>